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8" r:id="rId2"/>
    <p:sldId id="259" r:id="rId3"/>
  </p:sldIdLst>
  <p:sldSz cx="6480175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03F55"/>
    <a:srgbClr val="EAC553"/>
    <a:srgbClr val="5EA693"/>
    <a:srgbClr val="167998"/>
    <a:srgbClr val="2495B7"/>
    <a:srgbClr val="1A5D76"/>
    <a:srgbClr val="EDA848"/>
    <a:srgbClr val="EF893B"/>
    <a:srgbClr val="F0682F"/>
    <a:srgbClr val="D8513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45" autoAdjust="0"/>
    <p:restoredTop sz="82722" autoAdjust="0"/>
  </p:normalViewPr>
  <p:slideViewPr>
    <p:cSldViewPr snapToGrid="0">
      <p:cViewPr>
        <p:scale>
          <a:sx n="75" d="100"/>
          <a:sy n="75" d="100"/>
        </p:scale>
        <p:origin x="509" y="-6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03CE22-5AE2-42C4-B0BB-98E7242E595A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43000"/>
            <a:ext cx="2019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6E8813-9366-4E2F-8C31-D2655CE1E8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97572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621191"/>
            <a:ext cx="5508149" cy="3448756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5202944"/>
            <a:ext cx="4860131" cy="2391656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5983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544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527403"/>
            <a:ext cx="1397288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527403"/>
            <a:ext cx="4110861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5370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2108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469624"/>
            <a:ext cx="5589151" cy="4120620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629226"/>
            <a:ext cx="5589151" cy="216693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424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637014"/>
            <a:ext cx="2754074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637014"/>
            <a:ext cx="2754074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0784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7405"/>
            <a:ext cx="5589151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428347"/>
            <a:ext cx="2741417" cy="1190095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618442"/>
            <a:ext cx="2741417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428347"/>
            <a:ext cx="2754918" cy="1190095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618442"/>
            <a:ext cx="2754918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4467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5205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7226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60400"/>
            <a:ext cx="2090025" cy="23114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426283"/>
            <a:ext cx="3280589" cy="7039681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71800"/>
            <a:ext cx="2090025" cy="55056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5760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60400"/>
            <a:ext cx="2090025" cy="23114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426283"/>
            <a:ext cx="3280589" cy="7039681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71800"/>
            <a:ext cx="2090025" cy="55056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3904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527405"/>
            <a:ext cx="5589151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637014"/>
            <a:ext cx="5589151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9181397"/>
            <a:ext cx="145803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E30FE-4D7A-4A97-84AA-7B64AD4E3054}" type="datetimeFigureOut">
              <a:rPr lang="ko-KR" altLang="en-US" smtClean="0"/>
              <a:t>2025-06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9181397"/>
            <a:ext cx="218705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9181397"/>
            <a:ext cx="145803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19B518-5ECB-4B91-A021-C5C87BFFA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065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1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F489EB0B-5094-48D9-9FC5-C280A72B8BE1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407" y="890563"/>
            <a:ext cx="5039360" cy="377952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C2BD335-6B84-4668-A156-DE1061EC6053}"/>
              </a:ext>
            </a:extLst>
          </p:cNvPr>
          <p:cNvSpPr txBox="1"/>
          <p:nvPr/>
        </p:nvSpPr>
        <p:spPr>
          <a:xfrm>
            <a:off x="392290" y="427040"/>
            <a:ext cx="1167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cs typeface="Arial" panose="020B0604020202020204" pitchFamily="34" charset="0"/>
              </a:rPr>
              <a:t>Supple Figure 1</a:t>
            </a:r>
            <a:endParaRPr lang="ko-KR" altLang="en-US" sz="1200" b="1" dirty="0">
              <a:cs typeface="Arial" panose="020B0604020202020204" pitchFamily="34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990600" y="4856607"/>
            <a:ext cx="4769167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b="1" kern="100" dirty="0">
                <a:cs typeface="Times New Roman" panose="02020603050405020304" pitchFamily="18" charset="0"/>
              </a:rPr>
              <a:t>Supplementary Figure 1. Network degree distribution. </a:t>
            </a:r>
            <a:r>
              <a:rPr lang="en-US" altLang="ko-KR" sz="1100" kern="100" dirty="0">
                <a:cs typeface="Times New Roman" panose="02020603050405020304" pitchFamily="18" charset="0"/>
              </a:rPr>
              <a:t>Analysis of node degree distribution in the high-confidence </a:t>
            </a:r>
            <a:r>
              <a:rPr lang="en-US" altLang="ko-KR" sz="1100" kern="100" dirty="0" err="1">
                <a:cs typeface="Times New Roman" panose="02020603050405020304" pitchFamily="18" charset="0"/>
              </a:rPr>
              <a:t>MagNet</a:t>
            </a:r>
            <a:r>
              <a:rPr lang="en-US" altLang="ko-KR" sz="1100" kern="100" dirty="0">
                <a:cs typeface="Times New Roman" panose="02020603050405020304" pitchFamily="18" charset="0"/>
              </a:rPr>
              <a:t> network, demonstrating characteristics typical of scale-free biological networks.</a:t>
            </a:r>
            <a:endParaRPr lang="ko-KR" altLang="ko-KR" sz="900" kern="1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0888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래픽 6">
            <a:extLst>
              <a:ext uri="{FF2B5EF4-FFF2-40B4-BE49-F238E27FC236}">
                <a16:creationId xmlns:a16="http://schemas.microsoft.com/office/drawing/2014/main" id="{A81AD179-F823-F344-90AF-12170282BB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81354" y="506094"/>
            <a:ext cx="5358918" cy="1942465"/>
          </a:xfrm>
          <a:prstGeom prst="rect">
            <a:avLst/>
          </a:prstGeom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90EF61FB-74ED-E7C1-1D65-AB6BC404D4C9}"/>
              </a:ext>
            </a:extLst>
          </p:cNvPr>
          <p:cNvSpPr/>
          <p:nvPr/>
        </p:nvSpPr>
        <p:spPr>
          <a:xfrm>
            <a:off x="681354" y="2570607"/>
            <a:ext cx="4769167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b="1" kern="100" dirty="0">
                <a:cs typeface="Times New Roman" panose="02020603050405020304" pitchFamily="18" charset="0"/>
              </a:rPr>
              <a:t>Supplementary Figure 2. Computational validation of </a:t>
            </a:r>
            <a:r>
              <a:rPr lang="en-US" altLang="ko-KR" sz="1100" b="1" kern="100" dirty="0" err="1">
                <a:cs typeface="Times New Roman" panose="02020603050405020304" pitchFamily="18" charset="0"/>
              </a:rPr>
              <a:t>MagNet</a:t>
            </a:r>
            <a:r>
              <a:rPr lang="en-US" altLang="ko-KR" sz="1100" b="1" kern="100" dirty="0">
                <a:cs typeface="Times New Roman" panose="02020603050405020304" pitchFamily="18" charset="0"/>
              </a:rPr>
              <a:t>. </a:t>
            </a:r>
            <a:r>
              <a:rPr lang="en-US" altLang="ko-KR" sz="1100" kern="100" dirty="0">
                <a:cs typeface="Times New Roman" panose="02020603050405020304" pitchFamily="18" charset="0"/>
              </a:rPr>
              <a:t>Analysis of </a:t>
            </a:r>
            <a:r>
              <a:rPr lang="en-US" altLang="ko-KR" sz="1100" kern="100" dirty="0" err="1">
                <a:cs typeface="Times New Roman" panose="02020603050405020304" pitchFamily="18" charset="0"/>
              </a:rPr>
              <a:t>septin</a:t>
            </a:r>
            <a:r>
              <a:rPr lang="en-US" altLang="ko-KR" sz="1100" kern="100" dirty="0">
                <a:cs typeface="Times New Roman" panose="02020603050405020304" pitchFamily="18" charset="0"/>
              </a:rPr>
              <a:t> complex interactions across MPID, STRING, and high-confidence </a:t>
            </a:r>
            <a:r>
              <a:rPr lang="en-US" altLang="ko-KR" sz="1100" kern="100" dirty="0" err="1">
                <a:cs typeface="Times New Roman" panose="02020603050405020304" pitchFamily="18" charset="0"/>
              </a:rPr>
              <a:t>MagNet</a:t>
            </a:r>
            <a:r>
              <a:rPr lang="en-US" altLang="ko-KR" sz="1100" kern="100" dirty="0">
                <a:cs typeface="Times New Roman" panose="02020603050405020304" pitchFamily="18" charset="0"/>
              </a:rPr>
              <a:t> networks.</a:t>
            </a:r>
            <a:endParaRPr lang="ko-KR" altLang="ko-KR" sz="900" kern="1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9597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91</TotalTime>
  <Words>54</Words>
  <Application>Microsoft Office PowerPoint</Application>
  <PresentationFormat>사용자 지정</PresentationFormat>
  <Paragraphs>3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Kayden</dc:creator>
  <cp:lastModifiedBy>You-Jin Lim</cp:lastModifiedBy>
  <cp:revision>39</cp:revision>
  <dcterms:created xsi:type="dcterms:W3CDTF">2020-06-22T23:50:15Z</dcterms:created>
  <dcterms:modified xsi:type="dcterms:W3CDTF">2025-06-02T04:02:11Z</dcterms:modified>
</cp:coreProperties>
</file>